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65" r:id="rId4"/>
    <p:sldId id="260" r:id="rId5"/>
    <p:sldId id="261" r:id="rId6"/>
    <p:sldId id="262" r:id="rId7"/>
    <p:sldId id="263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2351" t="1753" r="4632" b="23805"/>
          <a:stretch/>
        </p:blipFill>
        <p:spPr>
          <a:xfrm>
            <a:off x="1690778" y="414068"/>
            <a:ext cx="8134710" cy="4882551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764156" y="1910080"/>
            <a:ext cx="150592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2697480" y="2197735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2797810" y="3244850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Xmag3124</a:t>
            </a:r>
          </a:p>
        </p:txBody>
      </p:sp>
      <p:sp>
        <p:nvSpPr>
          <p:cNvPr id="2" name="矩形 1"/>
          <p:cNvSpPr/>
          <p:nvPr/>
        </p:nvSpPr>
        <p:spPr>
          <a:xfrm>
            <a:off x="3796347" y="5646610"/>
            <a:ext cx="46740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Original gel images of Primer Xmag3124 in Fig. 4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BARC111BARC121ppd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5174" t="4546" r="1944" b="22270"/>
          <a:stretch/>
        </p:blipFill>
        <p:spPr>
          <a:xfrm>
            <a:off x="1587260" y="0"/>
            <a:ext cx="9342408" cy="5520906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8159115" y="1658620"/>
            <a:ext cx="2064385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8092440" y="1946275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8159115" y="2933700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Ppd-D1</a:t>
            </a:r>
          </a:p>
        </p:txBody>
      </p:sp>
      <p:sp>
        <p:nvSpPr>
          <p:cNvPr id="8" name="矩形 7"/>
          <p:cNvSpPr/>
          <p:nvPr/>
        </p:nvSpPr>
        <p:spPr>
          <a:xfrm>
            <a:off x="3796347" y="5646610"/>
            <a:ext cx="44095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Original gel images of Primer Ppd-D1 in Fig. 4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17765" b="21041"/>
          <a:stretch/>
        </p:blipFill>
        <p:spPr>
          <a:xfrm>
            <a:off x="2993366" y="212113"/>
            <a:ext cx="6605246" cy="4756701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6001972" y="2116478"/>
            <a:ext cx="135382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131262" y="3518558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BARC053</a:t>
            </a:r>
          </a:p>
        </p:txBody>
      </p:sp>
      <p:sp>
        <p:nvSpPr>
          <p:cNvPr id="5" name="矩形 4"/>
          <p:cNvSpPr/>
          <p:nvPr/>
        </p:nvSpPr>
        <p:spPr>
          <a:xfrm>
            <a:off x="4453207" y="2243478"/>
            <a:ext cx="135382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680662" y="3391558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BARC172</a:t>
            </a:r>
          </a:p>
        </p:txBody>
      </p:sp>
      <p:sp>
        <p:nvSpPr>
          <p:cNvPr id="8" name="矩形 7"/>
          <p:cNvSpPr/>
          <p:nvPr/>
        </p:nvSpPr>
        <p:spPr>
          <a:xfrm>
            <a:off x="2095658" y="5181593"/>
            <a:ext cx="86407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Original gel images of Primer BARC053 in Supplemental Fig. 2 and Primer BARC172 in Fig.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954416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Fig. 4-1"/>
          <p:cNvPicPr>
            <a:picLocks noChangeAspect="1"/>
          </p:cNvPicPr>
          <p:nvPr/>
        </p:nvPicPr>
        <p:blipFill rotWithShape="1">
          <a:blip r:embed="rId2"/>
          <a:srcRect r="1957" b="21051"/>
          <a:stretch/>
        </p:blipFill>
        <p:spPr>
          <a:xfrm>
            <a:off x="1591946" y="50800"/>
            <a:ext cx="7871232" cy="4754113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5524500" y="1083310"/>
            <a:ext cx="1574800" cy="112141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>
            <a:off x="4030980" y="3413125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GPW4344</a:t>
            </a:r>
          </a:p>
        </p:txBody>
      </p:sp>
      <p:sp>
        <p:nvSpPr>
          <p:cNvPr id="6" name="矩形 5"/>
          <p:cNvSpPr/>
          <p:nvPr/>
        </p:nvSpPr>
        <p:spPr>
          <a:xfrm>
            <a:off x="4250055" y="2205355"/>
            <a:ext cx="144907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5313680" y="2205355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bg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GPW7465</a:t>
            </a:r>
          </a:p>
        </p:txBody>
      </p:sp>
      <p:sp>
        <p:nvSpPr>
          <p:cNvPr id="9" name="矩形 8"/>
          <p:cNvSpPr/>
          <p:nvPr/>
        </p:nvSpPr>
        <p:spPr>
          <a:xfrm>
            <a:off x="2060959" y="5366544"/>
            <a:ext cx="7402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Original gel images of Primer GPW4344 and GPW7465 in Supplemental Fig.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312005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 contrast="2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" t="-579" r="3997" b="24218"/>
          <a:stretch/>
        </p:blipFill>
        <p:spPr>
          <a:xfrm>
            <a:off x="2225040" y="0"/>
            <a:ext cx="7721217" cy="4597879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4336415" y="3263265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Xgwm219</a:t>
            </a:r>
          </a:p>
        </p:txBody>
      </p:sp>
      <p:sp>
        <p:nvSpPr>
          <p:cNvPr id="6" name="矩形 5"/>
          <p:cNvSpPr/>
          <p:nvPr/>
        </p:nvSpPr>
        <p:spPr>
          <a:xfrm>
            <a:off x="4610735" y="1988185"/>
            <a:ext cx="144907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8" name="矩形 7"/>
          <p:cNvSpPr/>
          <p:nvPr/>
        </p:nvSpPr>
        <p:spPr>
          <a:xfrm>
            <a:off x="3294536" y="5251450"/>
            <a:ext cx="59424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Original gel images of Primer Xgwm219 in Supplemental Fig.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322288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9828" t="-1" r="394" b="25468"/>
          <a:stretch/>
        </p:blipFill>
        <p:spPr>
          <a:xfrm>
            <a:off x="2311879" y="0"/>
            <a:ext cx="7203057" cy="4485736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4841875" y="3168650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Xgdm35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3470275" y="3295650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Wmc245</a:t>
            </a:r>
          </a:p>
        </p:txBody>
      </p:sp>
      <p:sp>
        <p:nvSpPr>
          <p:cNvPr id="4" name="矩形 3"/>
          <p:cNvSpPr/>
          <p:nvPr/>
        </p:nvSpPr>
        <p:spPr>
          <a:xfrm>
            <a:off x="5290185" y="1905635"/>
            <a:ext cx="135382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5" name="矩形 4"/>
          <p:cNvSpPr/>
          <p:nvPr/>
        </p:nvSpPr>
        <p:spPr>
          <a:xfrm>
            <a:off x="3791585" y="2034540"/>
            <a:ext cx="135382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0" name="矩形 9"/>
          <p:cNvSpPr/>
          <p:nvPr/>
        </p:nvSpPr>
        <p:spPr>
          <a:xfrm>
            <a:off x="3225525" y="5159494"/>
            <a:ext cx="7124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Original gel images of Primer Wmc245 and Xgdm35 in Supplemental Fig.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263549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r="8403" b="21206"/>
          <a:stretch/>
        </p:blipFill>
        <p:spPr>
          <a:xfrm>
            <a:off x="2041058" y="379563"/>
            <a:ext cx="7206459" cy="4649638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3317408" y="2414102"/>
            <a:ext cx="135382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996098" y="3689182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Xgdm77</a:t>
            </a:r>
          </a:p>
        </p:txBody>
      </p:sp>
      <p:sp>
        <p:nvSpPr>
          <p:cNvPr id="3" name="矩形 2"/>
          <p:cNvSpPr/>
          <p:nvPr/>
        </p:nvSpPr>
        <p:spPr>
          <a:xfrm>
            <a:off x="4760763" y="1965157"/>
            <a:ext cx="1353820" cy="12750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439453" y="3240237"/>
            <a:ext cx="1997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BARC095</a:t>
            </a:r>
          </a:p>
        </p:txBody>
      </p:sp>
      <p:sp>
        <p:nvSpPr>
          <p:cNvPr id="9" name="矩形 8"/>
          <p:cNvSpPr/>
          <p:nvPr/>
        </p:nvSpPr>
        <p:spPr>
          <a:xfrm>
            <a:off x="1828045" y="5555387"/>
            <a:ext cx="71463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Original gel images of Primer Xgdm77 and BARC095 in Supplemental Fig.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07628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99</Words>
  <Application>Microsoft Office PowerPoint</Application>
  <PresentationFormat>宽屏</PresentationFormat>
  <Paragraphs>20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微软雅黑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racy</dc:creator>
  <cp:lastModifiedBy>Li Xingfeng</cp:lastModifiedBy>
  <cp:revision>9</cp:revision>
  <dcterms:created xsi:type="dcterms:W3CDTF">2020-11-22T03:16:00Z</dcterms:created>
  <dcterms:modified xsi:type="dcterms:W3CDTF">2021-01-31T07:11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132</vt:lpwstr>
  </property>
</Properties>
</file>